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62" r:id="rId3"/>
    <p:sldId id="264" r:id="rId4"/>
    <p:sldId id="265" r:id="rId5"/>
    <p:sldId id="263" r:id="rId6"/>
    <p:sldId id="266" r:id="rId7"/>
    <p:sldId id="267" r:id="rId8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015" autoAdjust="0"/>
    <p:restoredTop sz="94660"/>
  </p:normalViewPr>
  <p:slideViewPr>
    <p:cSldViewPr snapToGrid="0">
      <p:cViewPr>
        <p:scale>
          <a:sx n="75" d="100"/>
          <a:sy n="75" d="100"/>
        </p:scale>
        <p:origin x="900" y="62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F7A1C73-9508-8CD7-573F-4D888CD728F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E6AA5F3D-62BC-6E6E-37E4-2AAD53FF5F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F238B0E-968B-E286-8738-9D78082341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04CB0F2-E840-949B-152E-B315860262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2A9CDF8-B45F-38DF-7078-68ABD2B0E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7921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04BCE73-36AB-C248-7A34-B8A4E16B6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A88CA88E-4CEF-209B-8E43-1235B12D01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EAC154F-EE25-5DC5-001F-24F7F3EDE3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F1F3A4B-29A0-4E10-B401-771741AB74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C8AD9932-D9C4-89F3-092E-8EEB727490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13389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0557DE79-BF71-9EA5-C26B-7D0759AE57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257F9179-F031-DB8F-B2AE-A4CDCE376CF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DCC2F44-4890-B8D5-6F77-B7B8F32154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9366976-D860-2E70-5DBC-1F626261CC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D4231B5-83B3-E93C-3950-F2192EC14E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95113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9942DCA-4C65-4B20-03EB-A690F68993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E588AB9-2510-EA91-C674-41940109F0B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342643C-7A83-C640-0CFE-799C7297F9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82E8FCB-5BDB-0A7A-7F27-4524A276F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0FA7238-8EA0-CFD4-D91B-C42C9AF661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97372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6E87390C-32D4-F586-B830-1E261099E1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AEF7DB8-0B40-6146-FC5C-31B885D044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9B562A3-2BBC-DCF8-5FCD-F2121DA2EA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B6BA22-963D-28B5-3F3B-3D23F211C6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4B4E18-20E3-0528-5FB6-CB4D864E7C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7970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A8AB65-0F95-447E-D00C-7EDD65ABA5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7B5295C-8B08-CD0F-2493-DF8FDF24017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D8CFF3E-FA8D-B572-BF13-6C23081AA1E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FACFE6CE-A737-5DB1-B9EE-31CEF2CDF3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5661BEE-E6A9-E359-2EE4-22A80AED2E3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555E2FD-6E9C-A02B-E1FA-3D8E0F4EE4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90242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1D013B2-77BC-2F8D-977F-1E580B4F98B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3899188-753F-3429-8DD6-AAABEB686E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082EDB6-0FFD-BF33-6FC6-BD0137D88D7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4B645F73-60AE-4FC7-BA16-CE4F6C21F30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A1254190-535B-3FA2-4E27-ED0DE3296A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5DC8924-8946-B043-ACB1-23C5FBF29F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5D773E9B-C330-E018-372F-8B0777008F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CEC3511-6081-19BE-31AE-12ED403C11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9726281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51BEC0F-A0F9-1A3A-A756-77BDD86821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177AA90E-D9B7-821B-4B9B-CF39D3CE3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CD29D7A-113A-F0A8-2997-EB6BD451B1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DCF1BF05-D19C-F071-B127-F84B632EC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40442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EAE16DE-3803-60D7-960B-58F05F5D566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8D95A0F-3EBD-9848-8AEB-ADFCF074E8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5033396C-81AB-EC9B-0996-E4F2160F9D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25999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7211FA1-6B0A-9A73-680F-C1B87B13AA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93DAD79-2ED9-29D6-1298-FDDAD9A23FC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BBAE09F-3FB6-D0D6-3664-2A94F5EC8C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4EC5AACB-918F-3473-059D-EBBE6D317A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FB4BD83-26F8-C2D4-04E2-EADC4B3FA5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070F21D-3B25-F1AB-C38A-DD2B6AC43B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110888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7FEF43-6EFD-0DA0-2E21-DEC98D88C0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E8D86D14-735C-53CD-68AF-09517351283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0A4B4C78-8105-F727-1229-1CD1DE894B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0CA1B42-718F-EF7D-7897-2E851F68D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00BCB02-D083-62A7-B532-E0C0DCE03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75D5160B-8E89-7D52-61B0-565FE886AA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283240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3D55D4D4-EEA9-AC3A-D53B-A67326D836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6C0843D7-BE2F-B1DB-F46F-F284B647E9B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CEA70A8-1ECE-DC6E-50A4-CD63639397C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6DB74-FBED-434A-9B5F-5B9AD7364910}" type="datetimeFigureOut">
              <a:rPr lang="zh-CN" altLang="en-US" smtClean="0"/>
              <a:t>2026/6/2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D0E0674-B8D4-A08E-A2DF-37A35954A73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7E18B19-4B57-17B5-A441-14DD85D0C6D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36B25-F446-487D-889C-5CF6A1AD864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162926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4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png"/><Relationship Id="rId13" Type="http://schemas.microsoft.com/office/2007/relationships/hdphoto" Target="../media/hdphoto9.wdp"/><Relationship Id="rId3" Type="http://schemas.microsoft.com/office/2007/relationships/hdphoto" Target="../media/hdphoto4.wdp"/><Relationship Id="rId7" Type="http://schemas.microsoft.com/office/2007/relationships/hdphoto" Target="../media/hdphoto6.wdp"/><Relationship Id="rId12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11" Type="http://schemas.microsoft.com/office/2007/relationships/hdphoto" Target="../media/hdphoto8.wdp"/><Relationship Id="rId5" Type="http://schemas.microsoft.com/office/2007/relationships/hdphoto" Target="../media/hdphoto5.wdp"/><Relationship Id="rId10" Type="http://schemas.openxmlformats.org/officeDocument/2006/relationships/image" Target="../media/image9.png"/><Relationship Id="rId4" Type="http://schemas.openxmlformats.org/officeDocument/2006/relationships/image" Target="../media/image6.png"/><Relationship Id="rId9" Type="http://schemas.microsoft.com/office/2007/relationships/hdphoto" Target="../media/hdphoto7.wdp"/><Relationship Id="rId1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1.wdp"/><Relationship Id="rId3" Type="http://schemas.openxmlformats.org/officeDocument/2006/relationships/image" Target="../media/image13.png"/><Relationship Id="rId7" Type="http://schemas.openxmlformats.org/officeDocument/2006/relationships/image" Target="../media/image16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0.wdp"/><Relationship Id="rId11" Type="http://schemas.openxmlformats.org/officeDocument/2006/relationships/image" Target="../media/image18.png"/><Relationship Id="rId5" Type="http://schemas.openxmlformats.org/officeDocument/2006/relationships/image" Target="../media/image15.png"/><Relationship Id="rId10" Type="http://schemas.microsoft.com/office/2007/relationships/hdphoto" Target="../media/hdphoto12.wdp"/><Relationship Id="rId4" Type="http://schemas.openxmlformats.org/officeDocument/2006/relationships/image" Target="../media/image14.png"/><Relationship Id="rId9" Type="http://schemas.openxmlformats.org/officeDocument/2006/relationships/image" Target="../media/image17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6.xml.rels><?xml version="1.0" encoding="UTF-8" standalone="yes"?>
<Relationships xmlns="http://schemas.openxmlformats.org/package/2006/relationships"><Relationship Id="rId8" Type="http://schemas.microsoft.com/office/2007/relationships/hdphoto" Target="../media/hdphoto15.wdp"/><Relationship Id="rId3" Type="http://schemas.openxmlformats.org/officeDocument/2006/relationships/image" Target="../media/image23.png"/><Relationship Id="rId7" Type="http://schemas.openxmlformats.org/officeDocument/2006/relationships/image" Target="../media/image25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4.wdp"/><Relationship Id="rId5" Type="http://schemas.openxmlformats.org/officeDocument/2006/relationships/image" Target="../media/image24.png"/><Relationship Id="rId10" Type="http://schemas.microsoft.com/office/2007/relationships/hdphoto" Target="../media/hdphoto16.wdp"/><Relationship Id="rId4" Type="http://schemas.microsoft.com/office/2007/relationships/hdphoto" Target="../media/hdphoto13.wdp"/><Relationship Id="rId9" Type="http://schemas.openxmlformats.org/officeDocument/2006/relationships/image" Target="../media/image26.pn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19.wdp"/><Relationship Id="rId3" Type="http://schemas.openxmlformats.org/officeDocument/2006/relationships/image" Target="../media/image28.png"/><Relationship Id="rId7" Type="http://schemas.openxmlformats.org/officeDocument/2006/relationships/image" Target="../media/image30.png"/><Relationship Id="rId2" Type="http://schemas.openxmlformats.org/officeDocument/2006/relationships/image" Target="../media/image27.png"/><Relationship Id="rId1" Type="http://schemas.openxmlformats.org/officeDocument/2006/relationships/slideLayout" Target="../slideLayouts/slideLayout2.xml"/><Relationship Id="rId6" Type="http://schemas.microsoft.com/office/2007/relationships/hdphoto" Target="../media/hdphoto18.wdp"/><Relationship Id="rId5" Type="http://schemas.openxmlformats.org/officeDocument/2006/relationships/image" Target="../media/image29.png"/><Relationship Id="rId10" Type="http://schemas.microsoft.com/office/2007/relationships/hdphoto" Target="../media/hdphoto20.wdp"/><Relationship Id="rId4" Type="http://schemas.microsoft.com/office/2007/relationships/hdphoto" Target="../media/hdphoto17.wdp"/><Relationship Id="rId9" Type="http://schemas.openxmlformats.org/officeDocument/2006/relationships/image" Target="../media/image3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4970820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824CE53-A2FA-B951-795A-AB8D0AD236E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30EA8927-6279-2008-3365-902EE52F7B77}"/>
              </a:ext>
            </a:extLst>
          </p:cNvPr>
          <p:cNvSpPr txBox="1"/>
          <p:nvPr/>
        </p:nvSpPr>
        <p:spPr>
          <a:xfrm>
            <a:off x="1014557" y="1862118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BRM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914E1F1-EBBE-F460-732F-7C44CF4EE44D}"/>
              </a:ext>
            </a:extLst>
          </p:cNvPr>
          <p:cNvSpPr txBox="1"/>
          <p:nvPr/>
        </p:nvSpPr>
        <p:spPr>
          <a:xfrm>
            <a:off x="1014557" y="2800322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088B810-9C28-C094-5816-568BE048C82A}"/>
              </a:ext>
            </a:extLst>
          </p:cNvPr>
          <p:cNvSpPr txBox="1"/>
          <p:nvPr/>
        </p:nvSpPr>
        <p:spPr>
          <a:xfrm>
            <a:off x="1014556" y="3951452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3E37B64A-45E3-09B2-A9D3-4CAD606AC1B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3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38859" y="1688094"/>
            <a:ext cx="3979959" cy="663851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00AE761-6FB7-2C46-8C82-5C557E1812C2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5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38859" y="2636244"/>
            <a:ext cx="4066544" cy="79275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4776D68D-BF72-5344-0FD7-22D020F0AB52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12735" y="3721648"/>
            <a:ext cx="4375619" cy="828940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D87BB58A-5E3C-B536-6964-4A306EF3920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018808" y="1871928"/>
            <a:ext cx="3979959" cy="2185182"/>
          </a:xfrm>
          <a:prstGeom prst="rect">
            <a:avLst/>
          </a:prstGeom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D2D44C37-D1C0-5146-DFF6-A91E2ABBF886}"/>
              </a:ext>
            </a:extLst>
          </p:cNvPr>
          <p:cNvSpPr txBox="1"/>
          <p:nvPr/>
        </p:nvSpPr>
        <p:spPr>
          <a:xfrm>
            <a:off x="232892" y="288956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5I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矩形 3">
            <a:extLst>
              <a:ext uri="{FF2B5EF4-FFF2-40B4-BE49-F238E27FC236}">
                <a16:creationId xmlns:a16="http://schemas.microsoft.com/office/drawing/2014/main" id="{2F8892A2-2446-6303-6E69-B72FC0C37F2B}"/>
              </a:ext>
            </a:extLst>
          </p:cNvPr>
          <p:cNvSpPr/>
          <p:nvPr/>
        </p:nvSpPr>
        <p:spPr>
          <a:xfrm>
            <a:off x="2910348" y="1740310"/>
            <a:ext cx="3185652" cy="26547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8CDA3F1D-FEF1-98BE-7859-5C41E9F30479}"/>
              </a:ext>
            </a:extLst>
          </p:cNvPr>
          <p:cNvSpPr/>
          <p:nvPr/>
        </p:nvSpPr>
        <p:spPr>
          <a:xfrm>
            <a:off x="2989006" y="2904183"/>
            <a:ext cx="3185652" cy="26547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3163259D-55C0-579F-CF68-34CD10FD411C}"/>
              </a:ext>
            </a:extLst>
          </p:cNvPr>
          <p:cNvSpPr/>
          <p:nvPr/>
        </p:nvSpPr>
        <p:spPr>
          <a:xfrm>
            <a:off x="2989006" y="3924374"/>
            <a:ext cx="3185652" cy="26547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122365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74A31A9-D0B0-772F-6F5E-C5A5358FB2D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0870FA68-760D-7C9F-3186-CE3742CC730E}"/>
              </a:ext>
            </a:extLst>
          </p:cNvPr>
          <p:cNvSpPr txBox="1"/>
          <p:nvPr/>
        </p:nvSpPr>
        <p:spPr>
          <a:xfrm>
            <a:off x="1014557" y="1862118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BRM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B586661-1961-92ED-1323-A47CD3B3C98E}"/>
              </a:ext>
            </a:extLst>
          </p:cNvPr>
          <p:cNvSpPr txBox="1"/>
          <p:nvPr/>
        </p:nvSpPr>
        <p:spPr>
          <a:xfrm>
            <a:off x="1014557" y="2365682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29C70B5C-DA6D-1676-C973-0A2D98394986}"/>
              </a:ext>
            </a:extLst>
          </p:cNvPr>
          <p:cNvSpPr txBox="1"/>
          <p:nvPr/>
        </p:nvSpPr>
        <p:spPr>
          <a:xfrm>
            <a:off x="1014556" y="2768769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C22B798-73C8-D719-5C30-90364C84FCCB}"/>
              </a:ext>
            </a:extLst>
          </p:cNvPr>
          <p:cNvSpPr txBox="1"/>
          <p:nvPr/>
        </p:nvSpPr>
        <p:spPr>
          <a:xfrm>
            <a:off x="232892" y="288956"/>
            <a:ext cx="19798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5I Replicate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1DA805E6-6027-E0EF-13BC-34B6FA7BE25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12735" y="1841938"/>
            <a:ext cx="4269041" cy="36933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913674EE-4E0F-6932-1208-8A09FDDE1C0D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94135" y="3526731"/>
            <a:ext cx="2507226" cy="538201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9B49EA65-C69B-AC3A-5AEE-71F0C88E2C7A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12735" y="2370327"/>
            <a:ext cx="4269041" cy="30228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7007BBE1-6153-14D9-AE93-8DC35B57F9FB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94136" y="4097113"/>
            <a:ext cx="2507226" cy="521967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8CD1F703-DA06-889B-4F9D-0B8BE79C306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212735" y="2780889"/>
            <a:ext cx="4269041" cy="312506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3BED05CB-B547-A738-1A73-2EDE6997420C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94136" y="4684737"/>
            <a:ext cx="2507226" cy="412178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82D582E-30E8-53CD-0E0B-93D4AC6C3327}"/>
              </a:ext>
            </a:extLst>
          </p:cNvPr>
          <p:cNvSpPr txBox="1"/>
          <p:nvPr/>
        </p:nvSpPr>
        <p:spPr>
          <a:xfrm>
            <a:off x="1014557" y="3778085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BRM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50FD9AD0-EDDB-89D6-C339-CC7E8D295217}"/>
              </a:ext>
            </a:extLst>
          </p:cNvPr>
          <p:cNvSpPr txBox="1"/>
          <p:nvPr/>
        </p:nvSpPr>
        <p:spPr>
          <a:xfrm>
            <a:off x="1014557" y="4281649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8DB21F1E-1C67-1635-F54D-A1F8533DBB05}"/>
              </a:ext>
            </a:extLst>
          </p:cNvPr>
          <p:cNvSpPr txBox="1"/>
          <p:nvPr/>
        </p:nvSpPr>
        <p:spPr>
          <a:xfrm>
            <a:off x="1014556" y="4684736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33FD5D5B-942A-D02F-00B6-C8E841FEA3AB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5916351" y="3429000"/>
            <a:ext cx="4106500" cy="1725816"/>
          </a:xfrm>
          <a:prstGeom prst="rect">
            <a:avLst/>
          </a:prstGeom>
        </p:spPr>
      </p:pic>
      <p:sp>
        <p:nvSpPr>
          <p:cNvPr id="17" name="矩形 16">
            <a:extLst>
              <a:ext uri="{FF2B5EF4-FFF2-40B4-BE49-F238E27FC236}">
                <a16:creationId xmlns:a16="http://schemas.microsoft.com/office/drawing/2014/main" id="{485E3B8D-0E76-314A-0C86-BB99ABE1693B}"/>
              </a:ext>
            </a:extLst>
          </p:cNvPr>
          <p:cNvSpPr/>
          <p:nvPr/>
        </p:nvSpPr>
        <p:spPr>
          <a:xfrm>
            <a:off x="2730698" y="3778085"/>
            <a:ext cx="1841302" cy="1793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8" name="矩形 17">
            <a:extLst>
              <a:ext uri="{FF2B5EF4-FFF2-40B4-BE49-F238E27FC236}">
                <a16:creationId xmlns:a16="http://schemas.microsoft.com/office/drawing/2014/main" id="{161F174C-59AC-56D7-8FCB-75A13744A3B6}"/>
              </a:ext>
            </a:extLst>
          </p:cNvPr>
          <p:cNvSpPr/>
          <p:nvPr/>
        </p:nvSpPr>
        <p:spPr>
          <a:xfrm>
            <a:off x="2730698" y="4358096"/>
            <a:ext cx="1841302" cy="1793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2" name="矩形 21">
            <a:extLst>
              <a:ext uri="{FF2B5EF4-FFF2-40B4-BE49-F238E27FC236}">
                <a16:creationId xmlns:a16="http://schemas.microsoft.com/office/drawing/2014/main" id="{6072E0EC-32AC-00D9-99CA-801E9248880A}"/>
              </a:ext>
            </a:extLst>
          </p:cNvPr>
          <p:cNvSpPr/>
          <p:nvPr/>
        </p:nvSpPr>
        <p:spPr>
          <a:xfrm>
            <a:off x="2797373" y="4724809"/>
            <a:ext cx="1841302" cy="179399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466652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517B6B3-84EC-0FE2-6466-7582E04CB1B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本框 8">
            <a:extLst>
              <a:ext uri="{FF2B5EF4-FFF2-40B4-BE49-F238E27FC236}">
                <a16:creationId xmlns:a16="http://schemas.microsoft.com/office/drawing/2014/main" id="{BB4BB931-6997-6AAC-5975-B1415F356B1C}"/>
              </a:ext>
            </a:extLst>
          </p:cNvPr>
          <p:cNvSpPr txBox="1"/>
          <p:nvPr/>
        </p:nvSpPr>
        <p:spPr>
          <a:xfrm>
            <a:off x="1058143" y="1572425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BRM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3B635077-AA5B-D95C-CA88-0F91A6B1FA29}"/>
              </a:ext>
            </a:extLst>
          </p:cNvPr>
          <p:cNvSpPr txBox="1"/>
          <p:nvPr/>
        </p:nvSpPr>
        <p:spPr>
          <a:xfrm>
            <a:off x="1058143" y="2075989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13167DC4-8BD3-43AA-A0F9-D52EA8D263F9}"/>
              </a:ext>
            </a:extLst>
          </p:cNvPr>
          <p:cNvSpPr txBox="1"/>
          <p:nvPr/>
        </p:nvSpPr>
        <p:spPr>
          <a:xfrm>
            <a:off x="1058142" y="2479076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50E5E50E-4CA7-8F94-C857-B71E5942940D}"/>
              </a:ext>
            </a:extLst>
          </p:cNvPr>
          <p:cNvSpPr txBox="1"/>
          <p:nvPr/>
        </p:nvSpPr>
        <p:spPr>
          <a:xfrm>
            <a:off x="232892" y="288956"/>
            <a:ext cx="197984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5I Replicate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713C936-ED5B-63BF-6512-96AF2279A9D6}"/>
              </a:ext>
            </a:extLst>
          </p:cNvPr>
          <p:cNvSpPr txBox="1"/>
          <p:nvPr/>
        </p:nvSpPr>
        <p:spPr>
          <a:xfrm>
            <a:off x="1014557" y="3778085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PBRM1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F191B081-57D7-2B91-74B5-6CCA754D4C8C}"/>
              </a:ext>
            </a:extLst>
          </p:cNvPr>
          <p:cNvSpPr txBox="1"/>
          <p:nvPr/>
        </p:nvSpPr>
        <p:spPr>
          <a:xfrm>
            <a:off x="1014557" y="4281649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6BF7E6A7-79EB-794F-94DC-62A1EC0641E6}"/>
              </a:ext>
            </a:extLst>
          </p:cNvPr>
          <p:cNvSpPr txBox="1"/>
          <p:nvPr/>
        </p:nvSpPr>
        <p:spPr>
          <a:xfrm>
            <a:off x="1014556" y="4684736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AA9825A-FA52-B61E-950E-24EDF364F2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56321" y="1407152"/>
            <a:ext cx="5060520" cy="469726"/>
          </a:xfrm>
          <a:prstGeom prst="rect">
            <a:avLst/>
          </a:prstGeom>
        </p:spPr>
      </p:pic>
      <p:pic>
        <p:nvPicPr>
          <p:cNvPr id="16" name="图片 15">
            <a:extLst>
              <a:ext uri="{FF2B5EF4-FFF2-40B4-BE49-F238E27FC236}">
                <a16:creationId xmlns:a16="http://schemas.microsoft.com/office/drawing/2014/main" id="{52A59A1E-025D-080E-E492-08F68F7C226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56322" y="2044567"/>
            <a:ext cx="5060519" cy="394570"/>
          </a:xfrm>
          <a:prstGeom prst="rect">
            <a:avLst/>
          </a:prstGeom>
        </p:spPr>
      </p:pic>
      <p:pic>
        <p:nvPicPr>
          <p:cNvPr id="17" name="图片 16">
            <a:extLst>
              <a:ext uri="{FF2B5EF4-FFF2-40B4-BE49-F238E27FC236}">
                <a16:creationId xmlns:a16="http://schemas.microsoft.com/office/drawing/2014/main" id="{F4B2A8C2-69A9-FB70-BB86-977D2FD31C9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256321" y="2588250"/>
            <a:ext cx="5103093" cy="415145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2B0B33CC-B8AF-0DCB-9DEC-3B809701BD46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54768" y="5171595"/>
            <a:ext cx="3418073" cy="647067"/>
          </a:xfrm>
          <a:prstGeom prst="rect">
            <a:avLst/>
          </a:prstGeom>
        </p:spPr>
      </p:pic>
      <p:pic>
        <p:nvPicPr>
          <p:cNvPr id="20" name="图片 19">
            <a:extLst>
              <a:ext uri="{FF2B5EF4-FFF2-40B4-BE49-F238E27FC236}">
                <a16:creationId xmlns:a16="http://schemas.microsoft.com/office/drawing/2014/main" id="{2AB1B7E3-A3F2-B885-5D2A-13D615E25CE3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54769" y="4381967"/>
            <a:ext cx="3418074" cy="726457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2B5C4970-E9D2-93B5-CD2B-057008099AA1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1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54769" y="3657463"/>
            <a:ext cx="3418074" cy="623983"/>
          </a:xfrm>
          <a:prstGeom prst="rect">
            <a:avLst/>
          </a:prstGeom>
        </p:spPr>
      </p:pic>
      <p:pic>
        <p:nvPicPr>
          <p:cNvPr id="23" name="图片 22">
            <a:extLst>
              <a:ext uri="{FF2B5EF4-FFF2-40B4-BE49-F238E27FC236}">
                <a16:creationId xmlns:a16="http://schemas.microsoft.com/office/drawing/2014/main" id="{45E8DE6F-0FB7-F3CB-F952-2AFC0DF14A06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flipH="1">
            <a:off x="6225185" y="4006673"/>
            <a:ext cx="3802098" cy="13324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04306539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0DFB274-0170-A100-545C-BD2F8A298E9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CAAD0EB5-EBB0-F905-5D7B-46A41B9559F9}"/>
              </a:ext>
            </a:extLst>
          </p:cNvPr>
          <p:cNvSpPr txBox="1"/>
          <p:nvPr/>
        </p:nvSpPr>
        <p:spPr>
          <a:xfrm>
            <a:off x="1014557" y="2800322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FF096CCF-C5A8-7A15-7DDA-687B34B2D564}"/>
              </a:ext>
            </a:extLst>
          </p:cNvPr>
          <p:cNvSpPr txBox="1"/>
          <p:nvPr/>
        </p:nvSpPr>
        <p:spPr>
          <a:xfrm>
            <a:off x="1014556" y="3759477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381FA7C-AB37-4056-7C5F-4AF4DB608635}"/>
              </a:ext>
            </a:extLst>
          </p:cNvPr>
          <p:cNvSpPr txBox="1"/>
          <p:nvPr/>
        </p:nvSpPr>
        <p:spPr>
          <a:xfrm>
            <a:off x="232892" y="288956"/>
            <a:ext cx="21524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4G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238DA85C-1193-BC60-BBEC-7F453EF0A88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12735" y="2299285"/>
            <a:ext cx="4331368" cy="1002074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C1FA2FEA-A9A7-BB98-AFAC-A73C41742F2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212735" y="3376090"/>
            <a:ext cx="4424133" cy="1136107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B6505E83-1C68-C954-BF44-F6408A204E6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986403" y="2473865"/>
            <a:ext cx="3597378" cy="19102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4761548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93750D11-6618-12D1-E3D2-4EF6487F248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41C2BE02-30FD-48EC-1B63-4736D499AD4C}"/>
              </a:ext>
            </a:extLst>
          </p:cNvPr>
          <p:cNvSpPr txBox="1"/>
          <p:nvPr/>
        </p:nvSpPr>
        <p:spPr>
          <a:xfrm>
            <a:off x="1094337" y="1450201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58E7BC5D-BA77-158D-979A-75E8C072221B}"/>
              </a:ext>
            </a:extLst>
          </p:cNvPr>
          <p:cNvSpPr txBox="1"/>
          <p:nvPr/>
        </p:nvSpPr>
        <p:spPr>
          <a:xfrm>
            <a:off x="1094336" y="1965115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AFE4202-C120-3CF2-283B-BD6DF6A41440}"/>
              </a:ext>
            </a:extLst>
          </p:cNvPr>
          <p:cNvSpPr txBox="1"/>
          <p:nvPr/>
        </p:nvSpPr>
        <p:spPr>
          <a:xfrm>
            <a:off x="232892" y="288956"/>
            <a:ext cx="2152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4G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eplicate 2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E993A62-6EFB-6D95-A427-7FC2CBAC23FB}"/>
              </a:ext>
            </a:extLst>
          </p:cNvPr>
          <p:cNvSpPr txBox="1"/>
          <p:nvPr/>
        </p:nvSpPr>
        <p:spPr>
          <a:xfrm>
            <a:off x="1094336" y="3684038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7BF96663-0260-9CA0-FDAC-97C5F19EADC1}"/>
              </a:ext>
            </a:extLst>
          </p:cNvPr>
          <p:cNvSpPr txBox="1"/>
          <p:nvPr/>
        </p:nvSpPr>
        <p:spPr>
          <a:xfrm>
            <a:off x="1094335" y="4747592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图片 8">
            <a:extLst>
              <a:ext uri="{FF2B5EF4-FFF2-40B4-BE49-F238E27FC236}">
                <a16:creationId xmlns:a16="http://schemas.microsoft.com/office/drawing/2014/main" id="{6CA9476B-721D-7640-1995-ED54DA3B0C7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48935" y="2635624"/>
            <a:ext cx="2319272" cy="1503082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EBA09EA5-CD0D-A07D-9479-A81EA4EF523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07249" y="1146602"/>
            <a:ext cx="2565549" cy="672931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5452CD6E-F2AB-EDB5-40DA-5773B8FBB7B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07249" y="1988103"/>
            <a:ext cx="2565549" cy="655917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02BE2EDC-AF65-D7A9-CDF3-641164F1D51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85391" y="3337746"/>
            <a:ext cx="2992610" cy="1029953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12AD3BE6-E23A-07F2-ADD3-B61722C491D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385391" y="4514995"/>
            <a:ext cx="2992611" cy="1001799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637FBFCB-1F0E-55FA-C381-79C5C020CECF}"/>
              </a:ext>
            </a:extLst>
          </p:cNvPr>
          <p:cNvSpPr/>
          <p:nvPr/>
        </p:nvSpPr>
        <p:spPr>
          <a:xfrm>
            <a:off x="3081798" y="3787899"/>
            <a:ext cx="1483852" cy="350807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" name="矩形 4">
            <a:extLst>
              <a:ext uri="{FF2B5EF4-FFF2-40B4-BE49-F238E27FC236}">
                <a16:creationId xmlns:a16="http://schemas.microsoft.com/office/drawing/2014/main" id="{22EEFAF1-0AD5-AE7B-C837-847B31C0EDCE}"/>
              </a:ext>
            </a:extLst>
          </p:cNvPr>
          <p:cNvSpPr/>
          <p:nvPr/>
        </p:nvSpPr>
        <p:spPr>
          <a:xfrm>
            <a:off x="3227848" y="4663402"/>
            <a:ext cx="1414002" cy="30864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8750850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B00B9E2-4FA4-F2C9-E830-F12E7078CA11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文本框 9">
            <a:extLst>
              <a:ext uri="{FF2B5EF4-FFF2-40B4-BE49-F238E27FC236}">
                <a16:creationId xmlns:a16="http://schemas.microsoft.com/office/drawing/2014/main" id="{A8F506E8-40B9-1BBD-DF3C-EDA74FE0459F}"/>
              </a:ext>
            </a:extLst>
          </p:cNvPr>
          <p:cNvSpPr txBox="1"/>
          <p:nvPr/>
        </p:nvSpPr>
        <p:spPr>
          <a:xfrm>
            <a:off x="1094337" y="1450201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93FAD2CD-B0CA-F721-1121-D9B76641162B}"/>
              </a:ext>
            </a:extLst>
          </p:cNvPr>
          <p:cNvSpPr txBox="1"/>
          <p:nvPr/>
        </p:nvSpPr>
        <p:spPr>
          <a:xfrm>
            <a:off x="1094336" y="1965115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C9A3E57-9A05-1533-037D-2777FA3C77CC}"/>
              </a:ext>
            </a:extLst>
          </p:cNvPr>
          <p:cNvSpPr txBox="1"/>
          <p:nvPr/>
        </p:nvSpPr>
        <p:spPr>
          <a:xfrm>
            <a:off x="232892" y="288956"/>
            <a:ext cx="2152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4G</a:t>
            </a: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Replicate 3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CB56DF41-2B42-3B17-7049-3023FF9CBD2D}"/>
              </a:ext>
            </a:extLst>
          </p:cNvPr>
          <p:cNvSpPr txBox="1"/>
          <p:nvPr/>
        </p:nvSpPr>
        <p:spPr>
          <a:xfrm>
            <a:off x="1094336" y="3684038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CA9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DE3E572C-7C00-BED2-381A-70C7FC67AA44}"/>
              </a:ext>
            </a:extLst>
          </p:cNvPr>
          <p:cNvSpPr txBox="1"/>
          <p:nvPr/>
        </p:nvSpPr>
        <p:spPr>
          <a:xfrm>
            <a:off x="1094335" y="4831228"/>
            <a:ext cx="119817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C828095B-89E3-7F28-2437-C6D1BF8B21F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853081" y="2560954"/>
            <a:ext cx="3011563" cy="1492416"/>
          </a:xfrm>
          <a:prstGeom prst="rect">
            <a:avLst/>
          </a:prstGeom>
        </p:spPr>
      </p:pic>
      <p:pic>
        <p:nvPicPr>
          <p:cNvPr id="14" name="图片 13" descr="D:\Data\CA9_Data\20260602 患者标本PBRM1 wB\6\Administrator 2026-06-02 12 小时 40 分钟_Exposure_3.0sec.scn">
            <a:extLst>
              <a:ext uri="{FF2B5EF4-FFF2-40B4-BE49-F238E27FC236}">
                <a16:creationId xmlns:a16="http://schemas.microsoft.com/office/drawing/2014/main" id="{C39EDB89-6DE9-BBBA-8E08-049732D91BF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53864" y="1277507"/>
            <a:ext cx="2024525" cy="643010"/>
          </a:xfrm>
          <a:prstGeom prst="rect">
            <a:avLst/>
          </a:prstGeom>
        </p:spPr>
      </p:pic>
      <p:pic>
        <p:nvPicPr>
          <p:cNvPr id="15" name="图片 14" descr="D:\Data\CA9_Data\20260602 患者标本PBRM1 wB\6\Administrator 2026-06-02 12 小时 40 分钟_Exposure_3.0sec.scn">
            <a:extLst>
              <a:ext uri="{FF2B5EF4-FFF2-40B4-BE49-F238E27FC236}">
                <a16:creationId xmlns:a16="http://schemas.microsoft.com/office/drawing/2014/main" id="{E336052A-3E01-0831-B0F6-C19F3148787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37821" y="3425041"/>
            <a:ext cx="3173244" cy="887325"/>
          </a:xfrm>
          <a:prstGeom prst="rect">
            <a:avLst/>
          </a:prstGeom>
        </p:spPr>
      </p:pic>
      <p:pic>
        <p:nvPicPr>
          <p:cNvPr id="16" name="图片 15" descr="D:\Data\CA9_Data\20260602 患者标本PBRM1 wB\6\Administrator 2026-06-02 12 小时 40 分钟_Exposure_3.0sec.scn">
            <a:extLst>
              <a:ext uri="{FF2B5EF4-FFF2-40B4-BE49-F238E27FC236}">
                <a16:creationId xmlns:a16="http://schemas.microsoft.com/office/drawing/2014/main" id="{BE73A35F-D724-41FA-1E4D-924C5AF93A02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553864" y="2050939"/>
            <a:ext cx="2024525" cy="397675"/>
          </a:xfrm>
          <a:prstGeom prst="rect">
            <a:avLst/>
          </a:prstGeom>
        </p:spPr>
      </p:pic>
      <p:pic>
        <p:nvPicPr>
          <p:cNvPr id="17" name="图片 16" descr="D:\Data\CA9_Data\20260602 患者标本PBRM1 wB\6\Administrator 2026-06-02 12 小时 40 分钟_Exposure_3.0sec.scn">
            <a:extLst>
              <a:ext uri="{FF2B5EF4-FFF2-40B4-BE49-F238E27FC236}">
                <a16:creationId xmlns:a16="http://schemas.microsoft.com/office/drawing/2014/main" id="{5FF9308E-9D3F-162F-662F-2156C80D6E18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637821" y="4556691"/>
            <a:ext cx="3173244" cy="971777"/>
          </a:xfrm>
          <a:prstGeom prst="rect">
            <a:avLst/>
          </a:prstGeom>
        </p:spPr>
      </p:pic>
      <p:sp>
        <p:nvSpPr>
          <p:cNvPr id="4" name="矩形 3">
            <a:extLst>
              <a:ext uri="{FF2B5EF4-FFF2-40B4-BE49-F238E27FC236}">
                <a16:creationId xmlns:a16="http://schemas.microsoft.com/office/drawing/2014/main" id="{0A83FC54-FEEC-3AFF-4938-39DC419085CD}"/>
              </a:ext>
            </a:extLst>
          </p:cNvPr>
          <p:cNvSpPr/>
          <p:nvPr/>
        </p:nvSpPr>
        <p:spPr>
          <a:xfrm>
            <a:off x="3270250" y="3684038"/>
            <a:ext cx="1308139" cy="430762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970DB018-5802-0707-D9EC-073907EF7F71}"/>
              </a:ext>
            </a:extLst>
          </p:cNvPr>
          <p:cNvSpPr/>
          <p:nvPr/>
        </p:nvSpPr>
        <p:spPr>
          <a:xfrm>
            <a:off x="3359150" y="4571362"/>
            <a:ext cx="1327150" cy="366121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203148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45</Words>
  <Application>Microsoft Office PowerPoint</Application>
  <PresentationFormat>宽屏</PresentationFormat>
  <Paragraphs>33</Paragraphs>
  <Slides>7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7</vt:i4>
      </vt:variant>
    </vt:vector>
  </HeadingPairs>
  <TitlesOfParts>
    <vt:vector size="11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凯磊 陈</dc:creator>
  <cp:lastModifiedBy>凯磊 陈</cp:lastModifiedBy>
  <cp:revision>11</cp:revision>
  <dcterms:created xsi:type="dcterms:W3CDTF">2026-01-25T14:58:05Z</dcterms:created>
  <dcterms:modified xsi:type="dcterms:W3CDTF">2026-06-02T11:27:07Z</dcterms:modified>
</cp:coreProperties>
</file>